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17E5E-A91F-423D-9F6E-AF21880A5B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448B80-2DB4-48E1-9F3C-8C9F54A777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759E3-927B-4C6A-8CC4-7AFB935F1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786D9-E915-4867-A7D0-64556599A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F361C5-4912-4E2A-AE3F-14A7838AD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372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C47CA-F918-445C-87EC-951F9869E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B415E9-A4C5-425D-8B0F-2C3E169D0A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EE858F-90C2-4E38-A613-8B95692EA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353AE-C17E-457F-AAFE-CB656280C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131BD-F2A3-4DE2-8184-9479F8055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449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EC2CA6-9B43-49CA-BBFA-C7C7DE5475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AE835C-EA37-458D-A52B-B0EFA8E3ED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D6227C-1680-4422-98D4-511053F4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D16BF3-D589-4DDB-8530-7BCE215F9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FE79D8-FC5F-467B-B2BA-2A697034D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318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571912-ED93-437E-B3A4-05D0EBF45E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A2DE5F-1D6C-46F4-858A-BF2BB5FBA9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E2B64A-A487-404E-981A-538779B1F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42540-B050-47C7-9859-816C29209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A56E56-BC7C-4307-9F09-F542E0B7B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1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6638E-27AB-4D05-B57A-45BBBCA639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2E6493-1F80-49FF-A121-267EDFBBE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EA7389-75B8-4BBF-9896-8F7AC0C39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65C8BD-930A-44F5-89C0-589D86192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178243-1231-4530-9693-49434C78A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407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B9998-D597-4FD8-A4DD-FEB5417D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69FCF5-576F-4AC5-8DB7-83D8F36F9F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A49ED7-EA05-4D2C-B738-1EAC0CF1A4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050202-DB69-4B9D-9D7F-FC11E3A88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76186E-31CF-462D-B1DC-1B6CAB688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309DA0-5E90-4449-9C20-7B534B9A8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73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C587D-1025-4045-93E9-EEAD4373F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CE36E5-EDE2-40B4-AC48-B74BBE48F0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379701-58EA-4FD7-B529-6359400729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2DA684-61B2-4BAD-8041-EE118B9F2F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2F147D-2480-464A-8D94-960E991B08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7C6C32B-A57F-4FE9-AB29-7F6EEA377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2C3011-115E-44FB-9E51-D20A16349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EE301D-2D12-4193-A5A2-A27F20D95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34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B5C3A-18B1-45AD-98D3-5B688C3B6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7FF81E-90D3-43BD-BAC2-252C8FFEB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DDBFA8-B73F-4202-9678-AE3935DFD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4A7892-4E72-4D43-8A22-A88694074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464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5E56AE-AC3A-47F9-8E2D-3BAAFC18B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50E1B7-EA49-4DA0-8AE5-8FE261FC2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3C6ACA-91E8-4286-80C6-33EEF21F4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09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2689B-786D-46E6-979B-A3553D276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236F1-CF81-4095-B219-8724E147AF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65393A-0046-4EC1-A412-797C61141B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DC1D58-D119-44A7-B504-5A2E7AB32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CC9D0-A869-4CA9-91E2-B5FEB42C5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DBB7C7-E548-4453-BCFB-FF9F15550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641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F753CA-9089-4884-AB53-C72DABC3A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A6E6FF-A973-4C54-9480-9111AB1264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17C56C-2EEB-41A1-A207-CE7F89D459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7AB218-7FDE-49AC-86AE-294307782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E082B8-2377-483F-B42F-EFFAE8022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C968F3-2263-4A01-8AD9-958A6A914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954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21E649-BC56-4C31-9863-F286727E2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CBE8E-3078-40D2-9B11-C61FB2C96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B53793-7602-4CF1-9E9B-DFCABD26A3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0E171-12B0-4926-B476-C7FE9DD9AA32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7CE69E-651C-4F49-8D92-9CF184C9B8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E31352-388E-49E8-A105-C1D3106333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0FC08-04DB-458A-9BC1-759BE6B7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144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0240828"/>
              </p:ext>
            </p:extLst>
          </p:nvPr>
        </p:nvGraphicFramePr>
        <p:xfrm>
          <a:off x="707255" y="543615"/>
          <a:ext cx="10777490" cy="2609369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20126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074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5573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48403"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Arial" pitchFamily="34" charset="0"/>
                          <a:cs typeface="Arial" pitchFamily="34" charset="0"/>
                        </a:rPr>
                        <a:t>Dataset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Arial" pitchFamily="34" charset="0"/>
                          <a:cs typeface="Arial" pitchFamily="34" charset="0"/>
                        </a:rPr>
                        <a:t>Databas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2400" dirty="0">
                          <a:latin typeface="Arial" pitchFamily="34" charset="0"/>
                          <a:cs typeface="Arial" pitchFamily="34" charset="0"/>
                        </a:rPr>
                        <a:t>Reference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1929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Genetic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NCBI – Gen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https://www.ncbi.nlm.nih.gov/gene?Db=gene&amp;Cmd=ShowDetailView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0660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Genomic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GWAS</a:t>
                      </a:r>
                      <a:r>
                        <a:rPr lang="en-US" sz="1600" baseline="0" dirty="0">
                          <a:latin typeface="Arial" pitchFamily="34" charset="0"/>
                          <a:cs typeface="Arial" pitchFamily="34" charset="0"/>
                        </a:rPr>
                        <a:t> catalog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http://www.ebi.ac.uk/gwas/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3909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mRNA</a:t>
                      </a:r>
                      <a:r>
                        <a:rPr lang="en-US" sz="1600" baseline="0" dirty="0">
                          <a:latin typeface="Arial" pitchFamily="34" charset="0"/>
                          <a:cs typeface="Arial" pitchFamily="34" charset="0"/>
                        </a:rPr>
                        <a:t> levels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GTEx</a:t>
                      </a:r>
                      <a:r>
                        <a:rPr lang="en-US" sz="1600" baseline="0" dirty="0">
                          <a:latin typeface="Arial" pitchFamily="34" charset="0"/>
                          <a:cs typeface="Arial" pitchFamily="34" charset="0"/>
                        </a:rPr>
                        <a:t> Portal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https://www.gtexportal.org/home/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49609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Pharmacology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FAER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https://www.fda.gov/Drugs/GuidanceComplianceRegulatoryInformation/Surveillance/AdverseDrugEffects/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17937"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Pharmacology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 err="1">
                          <a:latin typeface="Arial" pitchFamily="34" charset="0"/>
                          <a:cs typeface="Arial" pitchFamily="34" charset="0"/>
                        </a:rPr>
                        <a:t>Drugbank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latin typeface="Arial" pitchFamily="34" charset="0"/>
                          <a:cs typeface="Arial" pitchFamily="34" charset="0"/>
                        </a:rPr>
                        <a:t>https://www.drugbank.ca/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arm User</dc:creator>
  <cp:lastModifiedBy>Pharm User</cp:lastModifiedBy>
  <cp:revision>1</cp:revision>
  <dcterms:created xsi:type="dcterms:W3CDTF">2019-01-28T17:57:31Z</dcterms:created>
  <dcterms:modified xsi:type="dcterms:W3CDTF">2019-01-28T17:58:18Z</dcterms:modified>
</cp:coreProperties>
</file>